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5" d="100"/>
          <a:sy n="85" d="100"/>
        </p:scale>
        <p:origin x="-117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-10-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H:\Personal research paper\paper4\Paper4 to Rice\Paper4 to Rice 8.5\sup figs new\S1 Fig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0029" y="1479295"/>
            <a:ext cx="7808395" cy="187769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251520" y="3573016"/>
            <a:ext cx="8384459" cy="1661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. S1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olymerase chain reaction (PCR) amplification of genomic DNA of autotetraploid rice hybrids using a marker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02-69. Lanes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 and 2 indicate the genotype of Taichung65-4x and E5-4x, Lanes 3-12 indicate the genotypes of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14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hybrid (Taichung65-4x×E5-4x), which under the interaction of </a:t>
            </a:r>
            <a:r>
              <a:rPr lang="en-US" altLang="zh-CN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a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ollen sterility locus.</a:t>
            </a:r>
            <a:endParaRPr lang="zh-CN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2807292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55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cp:lastModifiedBy>wjw</cp:lastModifiedBy>
  <cp:revision>5</cp:revision>
  <dcterms:modified xsi:type="dcterms:W3CDTF">2017-10-17T13:00:50Z</dcterms:modified>
</cp:coreProperties>
</file>